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7952" y="689531"/>
            <a:ext cx="86044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S was cultured with SKN and/or TNF-α for 24 h, then measured by MTT assay for cell cytotoxicity detection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1331640" y="5359486"/>
            <a:ext cx="446449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Absorbance at 492 nm; B, Absorbance at 492 nm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8644" y="2164214"/>
            <a:ext cx="6099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394121" y="2164214"/>
            <a:ext cx="6099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AD148E6-38FA-454D-8994-66A1C17EA00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5705" y="2775130"/>
            <a:ext cx="3328416" cy="238658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B1BC5B00-908E-4B5A-B8DC-29740DF3D80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8064" y="2772082"/>
            <a:ext cx="3273552" cy="23896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7186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39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Lianhua</cp:lastModifiedBy>
  <cp:revision>30</cp:revision>
  <dcterms:created xsi:type="dcterms:W3CDTF">2021-04-28T07:20:05Z</dcterms:created>
  <dcterms:modified xsi:type="dcterms:W3CDTF">2021-09-12T00:38:44Z</dcterms:modified>
</cp:coreProperties>
</file>